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75" userDrawn="1">
          <p15:clr>
            <a:srgbClr val="A4A3A4"/>
          </p15:clr>
        </p15:guide>
        <p15:guide id="2" pos="26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1929" y="60"/>
      </p:cViewPr>
      <p:guideLst>
        <p:guide orient="horz" pos="3175"/>
        <p:guide pos="26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4665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575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115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77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171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1214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650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989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0087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131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4397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93D96-D679-4695-B91E-49774347CE3C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8343D-1F81-495F-8D2C-DA18E8B51C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240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63568" y="3130184"/>
            <a:ext cx="522379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. Deletion </a:t>
            </a:r>
            <a:r>
              <a:rPr lang="en-GB" sz="1100" b="1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GB" sz="1100" b="1" smtClean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one H3-H4 gene pairs does not result in a rapid loss of proliferative capacity in G0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indicated strains were grown to mid log phase in EMM medium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rolif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and the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uspende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 EMM-N medium at 30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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 (-N)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for 4 days. Aliquots of the cultures were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ubjected to five-fold serial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lutions, spotte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onto YES agar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tes and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cubated at 30˚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 for 3-4 days until colonies had formed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081921" y="876983"/>
            <a:ext cx="3920913" cy="1742040"/>
            <a:chOff x="1172599" y="538316"/>
            <a:chExt cx="3045440" cy="1353072"/>
          </a:xfrm>
        </p:grpSpPr>
        <p:pic>
          <p:nvPicPr>
            <p:cNvPr id="24" name="Picture 4" descr="E:\Work\2010-2011\2011\June 2011\Nitrogen Starvation (27-06-11-01-07-11 ) Histone H3 mutants\Histone mutants t=3 t=4 spot test -n2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93" t="61639" r="63045" b="16134"/>
            <a:stretch/>
          </p:blipFill>
          <p:spPr bwMode="auto">
            <a:xfrm>
              <a:off x="1880419" y="762010"/>
              <a:ext cx="1073617" cy="11293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25" name="Group 24"/>
            <p:cNvGrpSpPr/>
            <p:nvPr/>
          </p:nvGrpSpPr>
          <p:grpSpPr>
            <a:xfrm>
              <a:off x="1172599" y="818709"/>
              <a:ext cx="672592" cy="1022185"/>
              <a:chOff x="276906" y="878796"/>
              <a:chExt cx="703517" cy="986938"/>
            </a:xfrm>
          </p:grpSpPr>
          <p:sp>
            <p:nvSpPr>
              <p:cNvPr id="26" name="TextBox 25"/>
              <p:cNvSpPr txBox="1"/>
              <p:nvPr/>
            </p:nvSpPr>
            <p:spPr>
              <a:xfrm>
                <a:off x="276906" y="1153332"/>
                <a:ext cx="703517" cy="1961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ht1</a:t>
                </a:r>
                <a:r>
                  <a:rPr lang="en-GB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hf1</a:t>
                </a:r>
                <a:r>
                  <a:rPr lang="en-GB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83698" y="878796"/>
                <a:ext cx="596725" cy="1961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ild type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76906" y="1415095"/>
                <a:ext cx="703517" cy="1961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ht2</a:t>
                </a:r>
                <a:r>
                  <a:rPr lang="en-GB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hf2</a:t>
                </a:r>
                <a:r>
                  <a:rPr lang="en-GB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76906" y="1669544"/>
                <a:ext cx="703517" cy="19619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ht3</a:t>
                </a:r>
                <a:r>
                  <a:rPr lang="en-GB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GB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hf3</a:t>
                </a:r>
                <a:r>
                  <a:rPr lang="en-GB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4" name="Picture 6" descr="E:\Work\2010-2011\2011\June 2011\Nitrogen Starvation (27-06-11-01-07-11 ) Histone H3 mutants\Histone mutants t=3 t=4 spot test -n2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39" t="7728" r="64873" b="69744"/>
            <a:stretch/>
          </p:blipFill>
          <p:spPr bwMode="auto">
            <a:xfrm>
              <a:off x="3145597" y="762010"/>
              <a:ext cx="1072442" cy="11293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2" name="TextBox 41"/>
            <p:cNvSpPr txBox="1"/>
            <p:nvPr/>
          </p:nvSpPr>
          <p:spPr>
            <a:xfrm>
              <a:off x="2209905" y="538316"/>
              <a:ext cx="393695" cy="2031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lif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4"/>
            <p:cNvSpPr txBox="1"/>
            <p:nvPr/>
          </p:nvSpPr>
          <p:spPr>
            <a:xfrm>
              <a:off x="3307022" y="538316"/>
              <a:ext cx="829472" cy="2031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0 (-N 4days)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278608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ff86b73-d2ed-45d1-9e31-5b4a0d263f49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9D959B2D8FA5C4980890EF71530081A" ma:contentTypeVersion="14" ma:contentTypeDescription="Create a new document." ma:contentTypeScope="" ma:versionID="32fa3c235032fb6ef437c97435266abb">
  <xsd:schema xmlns:xsd="http://www.w3.org/2001/XMLSchema" xmlns:xs="http://www.w3.org/2001/XMLSchema" xmlns:p="http://schemas.microsoft.com/office/2006/metadata/properties" xmlns:ns3="1ff86b73-d2ed-45d1-9e31-5b4a0d263f49" xmlns:ns4="917767b3-d7cc-4621-8ad9-27e46fe3c43e" targetNamespace="http://schemas.microsoft.com/office/2006/metadata/properties" ma:root="true" ma:fieldsID="b46a7b92e6b6a21088fcbb1ddad5d57c" ns3:_="" ns4:_="">
    <xsd:import namespace="1ff86b73-d2ed-45d1-9e31-5b4a0d263f49"/>
    <xsd:import namespace="917767b3-d7cc-4621-8ad9-27e46fe3c43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f86b73-d2ed-45d1-9e31-5b4a0d263f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17767b3-d7cc-4621-8ad9-27e46fe3c43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2725F01-9280-47CD-A6FD-2507A65A1F54}">
  <ds:schemaRefs>
    <ds:schemaRef ds:uri="http://purl.org/dc/elements/1.1/"/>
    <ds:schemaRef ds:uri="1ff86b73-d2ed-45d1-9e31-5b4a0d263f49"/>
    <ds:schemaRef ds:uri="http://purl.org/dc/terms/"/>
    <ds:schemaRef ds:uri="http://schemas.openxmlformats.org/package/2006/metadata/core-properties"/>
    <ds:schemaRef ds:uri="917767b3-d7cc-4621-8ad9-27e46fe3c43e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9C94222B-2B60-47E8-B3AB-1FD44B647A3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f86b73-d2ed-45d1-9e31-5b4a0d263f49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9F04B6C-7A5C-4EC0-9C98-AD25C266B4D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9</TotalTime>
  <Words>99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Whitehall</dc:creator>
  <cp:lastModifiedBy>Simon_Admin</cp:lastModifiedBy>
  <cp:revision>44</cp:revision>
  <cp:lastPrinted>2018-05-04T14:46:42Z</cp:lastPrinted>
  <dcterms:created xsi:type="dcterms:W3CDTF">2017-02-01T13:08:09Z</dcterms:created>
  <dcterms:modified xsi:type="dcterms:W3CDTF">2023-06-28T14:31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9D959B2D8FA5C4980890EF71530081A</vt:lpwstr>
  </property>
</Properties>
</file>